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5758FB7-9AC5-4552-8A53-C91805E547FA}" styleName="Style à thème 1 - Accentuation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957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77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75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847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265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2122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08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3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146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42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1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63CF-66D6-4D90-93C8-3779DBAACEBA}" type="datetimeFigureOut">
              <a:rPr lang="fr-FR" smtClean="0"/>
              <a:t>22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68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1339038"/>
              </p:ext>
            </p:extLst>
          </p:nvPr>
        </p:nvGraphicFramePr>
        <p:xfrm>
          <a:off x="1143000" y="3048000"/>
          <a:ext cx="4572000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1857889540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374207055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328567359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A1c</a:t>
                      </a:r>
                      <a:endParaRPr lang="fr-FR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0642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FD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9±1.5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0±0.09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88767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D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5±1.4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7±0.15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6897443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90041" y="4796500"/>
            <a:ext cx="6477917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 Table. </a:t>
            </a:r>
            <a:r>
              <a:rPr lang="en-GB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et-fed mice </a:t>
            </a:r>
            <a:r>
              <a:rPr lang="en-GB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. </a:t>
            </a:r>
            <a:r>
              <a:rPr lang="en-GB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GB" sz="1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 weeks of diet mice were evaluated for weight as well as HbA1c measurements from blood </a:t>
            </a:r>
            <a:r>
              <a:rPr lang="en-GB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ples of control LFD </a:t>
            </a:r>
            <a:r>
              <a:rPr lang="en-GB" sz="1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ese </a:t>
            </a:r>
            <a:r>
              <a:rPr lang="en-GB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perglycemic</a:t>
            </a:r>
            <a:r>
              <a:rPr lang="en-GB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FD </a:t>
            </a:r>
            <a:r>
              <a:rPr lang="en-GB" sz="1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e.</a:t>
            </a:r>
          </a:p>
        </p:txBody>
      </p:sp>
    </p:spTree>
    <p:extLst>
      <p:ext uri="{BB962C8B-B14F-4D97-AF65-F5344CB8AC3E}">
        <p14:creationId xmlns:p14="http://schemas.microsoft.com/office/powerpoint/2010/main" val="1681386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32</TotalTime>
  <Words>42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Uni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an Gosmain</dc:creator>
  <cp:lastModifiedBy>Yvan Gosmain</cp:lastModifiedBy>
  <cp:revision>181</cp:revision>
  <cp:lastPrinted>2018-10-26T15:14:21Z</cp:lastPrinted>
  <dcterms:created xsi:type="dcterms:W3CDTF">2018-03-28T11:59:25Z</dcterms:created>
  <dcterms:modified xsi:type="dcterms:W3CDTF">2019-01-22T12:17:31Z</dcterms:modified>
</cp:coreProperties>
</file>